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8" r:id="rId2"/>
  </p:sldIdLst>
  <p:sldSz cx="7315200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" userDrawn="1">
          <p15:clr>
            <a:srgbClr val="A4A3A4"/>
          </p15:clr>
        </p15:guide>
        <p15:guide id="2" pos="1872" userDrawn="1">
          <p15:clr>
            <a:srgbClr val="A4A3A4"/>
          </p15:clr>
        </p15:guide>
        <p15:guide id="3" orient="horz" pos="672" userDrawn="1">
          <p15:clr>
            <a:srgbClr val="A4A3A4"/>
          </p15:clr>
        </p15:guide>
        <p15:guide id="4" orient="horz" pos="2136" userDrawn="1">
          <p15:clr>
            <a:srgbClr val="A4A3A4"/>
          </p15:clr>
        </p15:guide>
        <p15:guide id="5" pos="2064" userDrawn="1">
          <p15:clr>
            <a:srgbClr val="A4A3A4"/>
          </p15:clr>
        </p15:guide>
        <p15:guide id="6" pos="504" userDrawn="1">
          <p15:clr>
            <a:srgbClr val="A4A3A4"/>
          </p15:clr>
        </p15:guide>
        <p15:guide id="7" orient="horz" pos="13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B1C8"/>
    <a:srgbClr val="FF0000"/>
    <a:srgbClr val="7FD7F7"/>
    <a:srgbClr val="FF9999"/>
    <a:srgbClr val="6EBAD6"/>
    <a:srgbClr val="00B0F0"/>
    <a:srgbClr val="0066FF"/>
    <a:srgbClr val="660033"/>
    <a:srgbClr val="FFFFCC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2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96"/>
      </p:cViewPr>
      <p:guideLst>
        <p:guide orient="horz" pos="1440"/>
        <p:guide pos="1872"/>
        <p:guide orient="horz" pos="672"/>
        <p:guide orient="horz" pos="2136"/>
        <p:guide pos="2064"/>
        <p:guide pos="504"/>
        <p:guide orient="horz" pos="13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748242"/>
            <a:ext cx="5486400" cy="1591733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2401359"/>
            <a:ext cx="5486400" cy="1103841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31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6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243417"/>
            <a:ext cx="1577340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43417"/>
            <a:ext cx="4640580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18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699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139826"/>
            <a:ext cx="6309360" cy="1901825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3059642"/>
            <a:ext cx="6309360" cy="1000125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42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43417"/>
            <a:ext cx="6309360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1120775"/>
            <a:ext cx="3094672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670050"/>
            <a:ext cx="3094672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120775"/>
            <a:ext cx="3109913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670050"/>
            <a:ext cx="3109913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86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2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05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658284"/>
            <a:ext cx="3703320" cy="3249083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4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658284"/>
            <a:ext cx="3703320" cy="3249083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8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43417"/>
            <a:ext cx="6309360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217083"/>
            <a:ext cx="6309360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4237567"/>
            <a:ext cx="246888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2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A911CC8-0AC6-4EEF-A706-67F697715D90}"/>
              </a:ext>
            </a:extLst>
          </p:cNvPr>
          <p:cNvSpPr txBox="1"/>
          <p:nvPr/>
        </p:nvSpPr>
        <p:spPr>
          <a:xfrm>
            <a:off x="0" y="53186"/>
            <a:ext cx="72294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: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estern blot confirms the presence of CD9, CD63, and TSG101 proteins (EVs markers) in cell culture extracted exosome, while the presence of Alpha-2-Macroglobulin (A2M) determined culture media protein contaminants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CF2A51F-854F-4DC6-BB8F-8BB608B454F7}"/>
              </a:ext>
            </a:extLst>
          </p:cNvPr>
          <p:cNvSpPr txBox="1"/>
          <p:nvPr/>
        </p:nvSpPr>
        <p:spPr>
          <a:xfrm>
            <a:off x="2138069" y="3100515"/>
            <a:ext cx="9209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CD9 </a:t>
            </a:r>
          </a:p>
          <a:p>
            <a:pPr algn="r"/>
            <a:r>
              <a:rPr lang="en-IN" sz="12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(27 </a:t>
            </a:r>
            <a:r>
              <a:rPr lang="en-IN" sz="1200" dirty="0" err="1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kDa</a:t>
            </a:r>
            <a:r>
              <a:rPr lang="en-IN" sz="1200" dirty="0"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)</a:t>
            </a:r>
            <a:endParaRPr lang="en-US" sz="12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5CCDBB8-7E39-4185-ACEE-0BB6411CBF87}"/>
              </a:ext>
            </a:extLst>
          </p:cNvPr>
          <p:cNvSpPr txBox="1"/>
          <p:nvPr/>
        </p:nvSpPr>
        <p:spPr>
          <a:xfrm>
            <a:off x="1932754" y="1736456"/>
            <a:ext cx="11262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A2M</a:t>
            </a:r>
          </a:p>
          <a:p>
            <a:pPr algn="r"/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20 </a:t>
            </a:r>
            <a:r>
              <a:rPr lang="en-US" sz="1200" dirty="0" err="1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4B3C2C6-F157-47C2-A9C7-A28F2BAFC13A}"/>
              </a:ext>
            </a:extLst>
          </p:cNvPr>
          <p:cNvGrpSpPr/>
          <p:nvPr/>
        </p:nvGrpSpPr>
        <p:grpSpPr>
          <a:xfrm>
            <a:off x="2231336" y="1239330"/>
            <a:ext cx="3006063" cy="2172255"/>
            <a:chOff x="2231336" y="1239330"/>
            <a:chExt cx="3006063" cy="2172255"/>
          </a:xfrm>
        </p:grpSpPr>
        <p:pic>
          <p:nvPicPr>
            <p:cNvPr id="8" name="Picture 7" descr="A picture containing indoor, photo, sitting, white&#10;&#10;Description automatically generated">
              <a:extLst>
                <a:ext uri="{FF2B5EF4-FFF2-40B4-BE49-F238E27FC236}">
                  <a16:creationId xmlns:a16="http://schemas.microsoft.com/office/drawing/2014/main" id="{1412CD6E-38EB-407E-9D81-B96408D10E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652" t="27676" r="45229" b="67424"/>
            <a:stretch/>
          </p:blipFill>
          <p:spPr>
            <a:xfrm>
              <a:off x="3273780" y="2168161"/>
              <a:ext cx="1699156" cy="375106"/>
            </a:xfrm>
            <a:prstGeom prst="rect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9" name="Picture 8" descr="A picture containing sitting, black, television, white&#10;&#10;Description automatically generated">
              <a:extLst>
                <a:ext uri="{FF2B5EF4-FFF2-40B4-BE49-F238E27FC236}">
                  <a16:creationId xmlns:a16="http://schemas.microsoft.com/office/drawing/2014/main" id="{3D4A1F49-2E4A-4DAC-8422-1DA7E290D5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652" t="29990" r="46366" b="56626"/>
            <a:stretch/>
          </p:blipFill>
          <p:spPr>
            <a:xfrm>
              <a:off x="3276600" y="2607535"/>
              <a:ext cx="1699156" cy="375106"/>
            </a:xfrm>
            <a:prstGeom prst="rect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E3D363E-694D-4D30-8A51-1D5D7E1501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rcRect l="4557" t="12895" r="52620" b="11186"/>
            <a:stretch/>
          </p:blipFill>
          <p:spPr>
            <a:xfrm>
              <a:off x="3276600" y="3036479"/>
              <a:ext cx="1699156" cy="375106"/>
            </a:xfrm>
            <a:prstGeom prst="rect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95BAFCC-82D5-4A8B-AB1F-4A20B12178E5}"/>
                </a:ext>
              </a:extLst>
            </p:cNvPr>
            <p:cNvSpPr txBox="1"/>
            <p:nvPr/>
          </p:nvSpPr>
          <p:spPr>
            <a:xfrm>
              <a:off x="2231336" y="2206780"/>
              <a:ext cx="83765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SG101 </a:t>
              </a:r>
            </a:p>
            <a:p>
              <a:pPr algn="r"/>
              <a:r>
                <a:rPr lang="en-IN" sz="12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(44 </a:t>
              </a:r>
              <a:r>
                <a:rPr lang="en-IN" sz="12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kDa</a:t>
              </a:r>
              <a:r>
                <a:rPr lang="en-IN" sz="12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5B95395-F981-44BB-8582-0D70B9B4A442}"/>
                </a:ext>
              </a:extLst>
            </p:cNvPr>
            <p:cNvSpPr txBox="1"/>
            <p:nvPr/>
          </p:nvSpPr>
          <p:spPr>
            <a:xfrm>
              <a:off x="2231336" y="2657927"/>
              <a:ext cx="8475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D63 </a:t>
              </a:r>
            </a:p>
            <a:p>
              <a:pPr algn="r"/>
              <a:r>
                <a:rPr lang="en-IN" sz="12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(27 </a:t>
              </a:r>
              <a:r>
                <a:rPr lang="en-IN" sz="1200" dirty="0" err="1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kDa</a:t>
              </a:r>
              <a:r>
                <a:rPr lang="en-IN" sz="1200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6CE6B941-7F00-44D7-B672-091EF442A6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5205" t="17512" r="50437" b="4238"/>
            <a:stretch/>
          </p:blipFill>
          <p:spPr>
            <a:xfrm>
              <a:off x="3268810" y="1728904"/>
              <a:ext cx="1699157" cy="366763"/>
            </a:xfrm>
            <a:prstGeom prst="rect">
              <a:avLst/>
            </a:prstGeom>
            <a:ln w="3175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A0EE25A-A68D-4805-8DB9-E38C107B26F7}"/>
                </a:ext>
              </a:extLst>
            </p:cNvPr>
            <p:cNvSpPr txBox="1"/>
            <p:nvPr/>
          </p:nvSpPr>
          <p:spPr>
            <a:xfrm>
              <a:off x="3128967" y="1431736"/>
              <a:ext cx="11262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xosome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0EFBE300-8625-4830-954B-C28396B08931}"/>
                </a:ext>
              </a:extLst>
            </p:cNvPr>
            <p:cNvCxnSpPr/>
            <p:nvPr/>
          </p:nvCxnSpPr>
          <p:spPr>
            <a:xfrm>
              <a:off x="2994445" y="1909454"/>
              <a:ext cx="274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2C2CD4F-AA44-4991-9347-0E0D50FA72F5}"/>
                </a:ext>
              </a:extLst>
            </p:cNvPr>
            <p:cNvSpPr txBox="1"/>
            <p:nvPr/>
          </p:nvSpPr>
          <p:spPr>
            <a:xfrm>
              <a:off x="4111108" y="1239330"/>
              <a:ext cx="112629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ost-Exosome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A948E7DD-E8D8-44F4-ABDA-AA4942D98EC9}"/>
                </a:ext>
              </a:extLst>
            </p:cNvPr>
            <p:cNvCxnSpPr/>
            <p:nvPr/>
          </p:nvCxnSpPr>
          <p:spPr>
            <a:xfrm>
              <a:off x="2994445" y="2341525"/>
              <a:ext cx="274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3786F4B9-0EB7-4E2E-AAD5-5D1256BC79FE}"/>
                </a:ext>
              </a:extLst>
            </p:cNvPr>
            <p:cNvCxnSpPr/>
            <p:nvPr/>
          </p:nvCxnSpPr>
          <p:spPr>
            <a:xfrm>
              <a:off x="3002280" y="2819140"/>
              <a:ext cx="274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C05A26E0-B972-447D-996B-77649A4694B2}"/>
                </a:ext>
              </a:extLst>
            </p:cNvPr>
            <p:cNvCxnSpPr/>
            <p:nvPr/>
          </p:nvCxnSpPr>
          <p:spPr>
            <a:xfrm>
              <a:off x="3002280" y="3217826"/>
              <a:ext cx="27432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06073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18</TotalTime>
  <Words>62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ip Patel</dc:creator>
  <cp:lastModifiedBy>Sandip</cp:lastModifiedBy>
  <cp:revision>246</cp:revision>
  <dcterms:created xsi:type="dcterms:W3CDTF">2020-03-03T17:34:57Z</dcterms:created>
  <dcterms:modified xsi:type="dcterms:W3CDTF">2020-12-25T06:38:44Z</dcterms:modified>
</cp:coreProperties>
</file>